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4" autoAdjust="0"/>
    <p:restoredTop sz="94660"/>
  </p:normalViewPr>
  <p:slideViewPr>
    <p:cSldViewPr snapToGrid="0">
      <p:cViewPr varScale="1">
        <p:scale>
          <a:sx n="94" d="100"/>
          <a:sy n="94" d="100"/>
        </p:scale>
        <p:origin x="50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2DBBA4-9B32-44F0-9310-8F819EA4B13C}" type="datetimeFigureOut">
              <a:rPr kumimoji="1" lang="ja-JP" altLang="en-US" smtClean="0"/>
              <a:t>2018/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EAAEFD-F603-4593-A843-21A05D969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91342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2DBBA4-9B32-44F0-9310-8F819EA4B13C}" type="datetimeFigureOut">
              <a:rPr kumimoji="1" lang="ja-JP" altLang="en-US" smtClean="0"/>
              <a:t>2018/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EAAEFD-F603-4593-A843-21A05D969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91873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2DBBA4-9B32-44F0-9310-8F819EA4B13C}" type="datetimeFigureOut">
              <a:rPr kumimoji="1" lang="ja-JP" altLang="en-US" smtClean="0"/>
              <a:t>2018/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EAAEFD-F603-4593-A843-21A05D969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62415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2DBBA4-9B32-44F0-9310-8F819EA4B13C}" type="datetimeFigureOut">
              <a:rPr kumimoji="1" lang="ja-JP" altLang="en-US" smtClean="0"/>
              <a:t>2018/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EAAEFD-F603-4593-A843-21A05D969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00150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2DBBA4-9B32-44F0-9310-8F819EA4B13C}" type="datetimeFigureOut">
              <a:rPr kumimoji="1" lang="ja-JP" altLang="en-US" smtClean="0"/>
              <a:t>2018/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EAAEFD-F603-4593-A843-21A05D969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59933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2DBBA4-9B32-44F0-9310-8F819EA4B13C}" type="datetimeFigureOut">
              <a:rPr kumimoji="1" lang="ja-JP" altLang="en-US" smtClean="0"/>
              <a:t>2018/1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EAAEFD-F603-4593-A843-21A05D969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85013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2DBBA4-9B32-44F0-9310-8F819EA4B13C}" type="datetimeFigureOut">
              <a:rPr kumimoji="1" lang="ja-JP" altLang="en-US" smtClean="0"/>
              <a:t>2018/1/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EAAEFD-F603-4593-A843-21A05D969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87552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2DBBA4-9B32-44F0-9310-8F819EA4B13C}" type="datetimeFigureOut">
              <a:rPr kumimoji="1" lang="ja-JP" altLang="en-US" smtClean="0"/>
              <a:t>2018/1/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EAAEFD-F603-4593-A843-21A05D969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75996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2DBBA4-9B32-44F0-9310-8F819EA4B13C}" type="datetimeFigureOut">
              <a:rPr kumimoji="1" lang="ja-JP" altLang="en-US" smtClean="0"/>
              <a:t>2018/1/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EAAEFD-F603-4593-A843-21A05D969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75411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2DBBA4-9B32-44F0-9310-8F819EA4B13C}" type="datetimeFigureOut">
              <a:rPr kumimoji="1" lang="ja-JP" altLang="en-US" smtClean="0"/>
              <a:t>2018/1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EAAEFD-F603-4593-A843-21A05D969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2197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2DBBA4-9B32-44F0-9310-8F819EA4B13C}" type="datetimeFigureOut">
              <a:rPr kumimoji="1" lang="ja-JP" altLang="en-US" smtClean="0"/>
              <a:t>2018/1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EAAEFD-F603-4593-A843-21A05D969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7086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2DBBA4-9B32-44F0-9310-8F819EA4B13C}" type="datetimeFigureOut">
              <a:rPr kumimoji="1" lang="ja-JP" altLang="en-US" smtClean="0"/>
              <a:t>2018/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EAAEFD-F603-4593-A843-21A05D969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56141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9117" y="733078"/>
            <a:ext cx="7344816" cy="4752528"/>
          </a:xfrm>
          <a:prstGeom prst="rect">
            <a:avLst/>
          </a:prstGeom>
          <a:noFill/>
          <a:ln>
            <a:noFill/>
          </a:ln>
          <a:extLst/>
        </p:spPr>
      </p:pic>
      <p:sp>
        <p:nvSpPr>
          <p:cNvPr id="3" name="テキスト ボックス 2"/>
          <p:cNvSpPr txBox="1"/>
          <p:nvPr/>
        </p:nvSpPr>
        <p:spPr>
          <a:xfrm>
            <a:off x="1736547" y="5801756"/>
            <a:ext cx="64198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/>
              <a:t>Figure S1</a:t>
            </a:r>
            <a:r>
              <a:rPr kumimoji="1" lang="en-US" altLang="ja-JP" dirty="0"/>
              <a:t>.</a:t>
            </a:r>
            <a:r>
              <a:rPr kumimoji="1" lang="ja-JP" altLang="en-US" dirty="0"/>
              <a:t> </a:t>
            </a:r>
            <a:r>
              <a:rPr lang="en-US" altLang="ja-JP" dirty="0"/>
              <a:t>Distribution of the lengths of the short read sequences obtained by </a:t>
            </a:r>
            <a:r>
              <a:rPr lang="en-US" altLang="ja-JP" dirty="0" err="1"/>
              <a:t>HiSeq</a:t>
            </a:r>
            <a:r>
              <a:rPr lang="en-US" altLang="ja-JP" dirty="0"/>
              <a:t> 2500 sequencing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4344508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17</Words>
  <Application>Microsoft Office PowerPoint</Application>
  <PresentationFormat>画面に合わせる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荒木　和男</dc:creator>
  <cp:lastModifiedBy>荒木　和男</cp:lastModifiedBy>
  <cp:revision>4</cp:revision>
  <dcterms:created xsi:type="dcterms:W3CDTF">2017-06-20T02:54:09Z</dcterms:created>
  <dcterms:modified xsi:type="dcterms:W3CDTF">2018-01-04T00:56:04Z</dcterms:modified>
</cp:coreProperties>
</file>